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45"/>
    <p:restoredTop sz="94676"/>
  </p:normalViewPr>
  <p:slideViewPr>
    <p:cSldViewPr snapToGrid="0" snapToObjects="1">
      <p:cViewPr varScale="1">
        <p:scale>
          <a:sx n="78" d="100"/>
          <a:sy n="78" d="100"/>
        </p:scale>
        <p:origin x="200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27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A0F3A36E-830C-0446-9EF6-214914090A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3444" y="1433013"/>
            <a:ext cx="2456377" cy="2456377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F59AC02C-F1AE-B840-9BF4-291BCF7086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1247" y="1433013"/>
            <a:ext cx="2456377" cy="2456377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AB729421-7CCF-8245-823E-F18E5D91FC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0123" y="3985565"/>
            <a:ext cx="2459698" cy="2459698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A9DAAE67-F728-EA4B-93C9-47FE26E63F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11247" y="4026089"/>
            <a:ext cx="2449243" cy="2449243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Figure 1: Validation of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unction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expression of Gpr101 in a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mouse model</a:t>
            </a:r>
            <a:endParaRPr lang="fr-FR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L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localizatio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FLAG-Gpr101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cth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sections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 (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29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n=4)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n=3 time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3112655" y="40260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2BBC823-4E1E-2043-8DF4-FFAB0B628CD0}"/>
              </a:ext>
            </a:extLst>
          </p:cNvPr>
          <p:cNvSpPr txBox="1"/>
          <p:nvPr/>
        </p:nvSpPr>
        <p:spPr>
          <a:xfrm>
            <a:off x="483445" y="4026089"/>
            <a:ext cx="195438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h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647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3112656" y="1433015"/>
            <a:ext cx="2447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</a:p>
          <a:p>
            <a:r>
              <a:rPr lang="fr-FR" sz="14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green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483445" y="143301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6488668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= 10µm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C10B67-9B7C-C942-B898-8BB4164F67E3}"/>
              </a:ext>
            </a:extLst>
          </p:cNvPr>
          <p:cNvSpPr/>
          <p:nvPr/>
        </p:nvSpPr>
        <p:spPr>
          <a:xfrm>
            <a:off x="5840346" y="1586903"/>
            <a:ext cx="6096000" cy="86177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cell nuclei</a:t>
            </a:r>
            <a:r>
              <a:rPr lang="en-US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nl-BE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PI</a:t>
            </a:r>
            <a:endParaRPr lang="fr-BE" dirty="0">
              <a:solidFill>
                <a:srgbClr val="00B0F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840346" y="2748816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FLAG-Gpr101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monoclonal mouse anti-FLAG antibody (Sigma–Aldrich, Cat. No F3165, clone M2, dilution 1:1000)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mouse IgG Fab2 Alexa Fluor 488 conjugate (Cell Signaling Technology, Cat. No 4408S, dilution 1:1000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12191ED-9094-254C-A587-35E25B72BD44}"/>
              </a:ext>
            </a:extLst>
          </p:cNvPr>
          <p:cNvSpPr/>
          <p:nvPr/>
        </p:nvSpPr>
        <p:spPr>
          <a:xfrm>
            <a:off x="5840346" y="4857452"/>
            <a:ext cx="6096000" cy="163121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</a:t>
            </a:r>
            <a:r>
              <a:rPr lang="en-US" sz="1600" u="sng" dirty="0" err="1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cth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mary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y: 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polyclonal rabbit anti-</a:t>
            </a:r>
            <a:r>
              <a:rPr lang="en-US" sz="1600" dirty="0" err="1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Acth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(</a:t>
            </a:r>
            <a:r>
              <a:rPr lang="en-US" sz="1600" dirty="0" err="1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Bioss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ies, Cat. No bs-0443R, dilution 1:50) </a:t>
            </a:r>
            <a:endParaRPr lang="fr-BE" sz="1600" dirty="0">
              <a:solidFill>
                <a:srgbClr val="FF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H+L) F(ab’)2 fragment Alexa Fluor 647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jugate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chnolog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at. No 4414, dilution 1:1000) </a:t>
            </a: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206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19</cp:revision>
  <dcterms:created xsi:type="dcterms:W3CDTF">2020-05-09T12:35:08Z</dcterms:created>
  <dcterms:modified xsi:type="dcterms:W3CDTF">2020-05-27T16:56:07Z</dcterms:modified>
</cp:coreProperties>
</file>